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75" d="100"/>
          <a:sy n="75" d="100"/>
        </p:scale>
        <p:origin x="48" y="3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AC2CCB-B51F-4657-9369-C257C225D21C}" type="datetimeFigureOut">
              <a:rPr kumimoji="1" lang="ja-JP" altLang="en-US" smtClean="0"/>
              <a:t>2022/2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9EF444-D2C1-459A-8C53-6A4BA477EC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40547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E4F0B9E-3C63-44F2-8803-CA43492CE86C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973962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4B1172-0CEE-4EC4-ABB2-798DCCBA3A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9DD4473-0A88-4F2C-9E4B-B0CFFDAC37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7B32B6-F1D7-4DEF-A198-F171EF3CE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86498AD-7A08-437E-9D24-A122C8C73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D14A1D-C7F1-4A79-995C-759940F8D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2215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0CD652-C4C5-4B0C-8877-BEBB54E71F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2B53007-C497-48A8-AA8C-032AEDCDC9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31D8330-B605-4C0B-B59E-7119B66B5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E6DBE3-F65E-421D-A5CA-C7D761D79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CC94571-4096-4894-BAD3-93E265383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07372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DEB6D69-38E8-4B09-A2F5-F5504EA6AB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180FB01-16C1-4CF5-8615-B19E7E8F90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84EE6F9-4B0D-4CD9-A1DA-98251F3FBA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417BED-2D4D-475D-9A58-7B37369DCE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FE3CAE-8434-4A60-97CA-6E730115F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6222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4A8528-80AA-4211-B7FC-7D4828D30A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2AAC3C4-9351-466A-9422-115DFB17D0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148CB4-E632-4C33-BB16-A9610592B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12387E-3B76-469A-801E-85B77F178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DC7C11-16ED-4E5F-9F3A-446F5599B9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25630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844D9B-19DF-498B-95AD-4046772016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332FA8E-E7DB-44FB-AE19-FD467D20FA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7E5276C-A6C5-4BA2-9C0D-A20C54CD6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8503AD-821E-42DC-A4E4-69F314AFE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0AFF84-EEB2-48CC-921C-1C214033D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66886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3FC209-95F6-418D-A6FE-A95A7579DF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22E18CB-9B1F-4995-B214-32718EF47B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EE60C69-C3DE-4D28-B73E-DBB1A8631A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9757826-9A42-4E4A-A309-2ABC7F2D1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E0C11EF-6AC9-4DBF-BAD4-E51CDE4F9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2C683CE-27F4-404D-A7F5-324198947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1523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2800D5-AAF8-42B0-B027-93207DA313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AE87EBA-292B-450F-B673-2193F59CBF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D3736AD-6D6C-4895-A902-4CB4549F4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1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38A7358-4893-4DE2-8AFA-910E082588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F9E494D-1244-477E-AADB-431AAA4DFC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203E97F-149C-49D5-9288-EB6C538F7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C5A2FB8-5407-4C38-AD31-EBC0FA0A6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BFBDE31-2AFD-46D4-B713-D2E4ADDC0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15999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D67077-9E09-4E2D-B598-AA5C4CAB42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1EFA71A-00DC-4442-BBC0-F0879FEF2B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C5A7074-AB93-4C12-B2AB-354D1BC81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34AB745-9C02-4869-9940-9C9953163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7708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D944341-0125-4878-8F53-4BACA201C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1EF8DD1-7FF2-4F82-9630-4FD1727CF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2F9617C-A9F9-47D8-B0D6-BD61A3722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641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D6B9EC-A9B6-45D3-A82F-FEC04C81A0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2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4A926D2-3602-459E-B90F-14DC7D5050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D7339DC-5B46-471D-9061-E4F61365D6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2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1FDFD64-DCD4-42B3-807E-B8458FD15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202311E-1667-4F67-9347-A2C97F1D4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47711DD-81CD-462A-9284-EFE39275D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37427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E7FEF7-4B99-4ABE-BD59-2C6748EFB1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2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A2DD494-CD01-4C08-A99F-2578AC2D55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BEA2C38-B0A3-4B5A-BD78-3FBD48A1B4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2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391C419-05F3-4186-96A8-A97B71569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9E4A4E5-E139-4D00-BD05-8561BB091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A7366F3-BF25-445F-9800-944EE30FF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97993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14B4C6C-8CE3-4F46-AE4C-D0FA6AC6E3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144477E-CE43-4700-9DA1-EB1BC5ECCC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5DADD00-B0C8-4C99-9FDD-218CD845AF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685800"/>
            <a:fld id="{169CD588-3BC6-4893-87CF-DD4CFAD2B1B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2022/2/6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7BA4C2A-887B-431E-9869-67F75A706D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685800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96FFC9-C3F4-4532-AEF5-272E88F3E4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685800"/>
            <a:fld id="{EBCDEEE7-4F78-479E-BD37-C5E52469057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685800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52086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5CD4A0C-0295-4606-925B-034B248FF89C}"/>
              </a:ext>
            </a:extLst>
          </p:cNvPr>
          <p:cNvSpPr txBox="1"/>
          <p:nvPr/>
        </p:nvSpPr>
        <p:spPr>
          <a:xfrm>
            <a:off x="3057789" y="786567"/>
            <a:ext cx="2872181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685800"/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Date of Data Access/Download</a:t>
            </a:r>
          </a:p>
          <a:p>
            <a:pPr algn="ctr" defTabSz="685800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1/January/2022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64BE7E3B-7766-422C-B1C4-4D4FE9BFB7EC}"/>
              </a:ext>
            </a:extLst>
          </p:cNvPr>
          <p:cNvCxnSpPr>
            <a:cxnSpLocks/>
            <a:stCxn id="5" idx="2"/>
            <a:endCxn id="18" idx="0"/>
          </p:cNvCxnSpPr>
          <p:nvPr/>
        </p:nvCxnSpPr>
        <p:spPr>
          <a:xfrm flipH="1">
            <a:off x="4493878" y="1325176"/>
            <a:ext cx="2" cy="53860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D4391F2-B2D9-464E-824E-6F06533A68D3}"/>
              </a:ext>
            </a:extLst>
          </p:cNvPr>
          <p:cNvSpPr txBox="1"/>
          <p:nvPr/>
        </p:nvSpPr>
        <p:spPr>
          <a:xfrm>
            <a:off x="3057788" y="1863785"/>
            <a:ext cx="2872180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685800"/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ocation</a:t>
            </a:r>
          </a:p>
          <a:p>
            <a:pPr algn="ctr" defTabSz="685800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Japan</a:t>
            </a:r>
            <a:endParaRPr lang="en-US" altLang="ja-JP" sz="1600" dirty="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08540E17-07EC-4632-939B-B5F3D0D98115}"/>
              </a:ext>
            </a:extLst>
          </p:cNvPr>
          <p:cNvCxnSpPr>
            <a:cxnSpLocks/>
            <a:stCxn id="18" idx="2"/>
            <a:endCxn id="26" idx="0"/>
          </p:cNvCxnSpPr>
          <p:nvPr/>
        </p:nvCxnSpPr>
        <p:spPr>
          <a:xfrm>
            <a:off x="4493878" y="2402394"/>
            <a:ext cx="0" cy="53860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FCAC0C9-DC06-478C-8992-F295FE973C1C}"/>
              </a:ext>
            </a:extLst>
          </p:cNvPr>
          <p:cNvSpPr txBox="1"/>
          <p:nvPr/>
        </p:nvSpPr>
        <p:spPr>
          <a:xfrm>
            <a:off x="3057787" y="2941003"/>
            <a:ext cx="2872181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685800"/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ime Period</a:t>
            </a:r>
          </a:p>
          <a:p>
            <a:pPr algn="ctr" defTabSz="685800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ach year of 2012 to 2021 </a:t>
            </a:r>
            <a:endParaRPr lang="en-US" altLang="ja-JP" sz="1600" dirty="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49A014A7-BB29-49AD-BB50-6FCD4FCF3947}"/>
              </a:ext>
            </a:extLst>
          </p:cNvPr>
          <p:cNvCxnSpPr>
            <a:cxnSpLocks/>
            <a:stCxn id="26" idx="2"/>
            <a:endCxn id="40" idx="0"/>
          </p:cNvCxnSpPr>
          <p:nvPr/>
        </p:nvCxnSpPr>
        <p:spPr>
          <a:xfrm>
            <a:off x="4493878" y="3479612"/>
            <a:ext cx="2" cy="53860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388927A-4C78-4D32-9D6D-88562D55C66E}"/>
              </a:ext>
            </a:extLst>
          </p:cNvPr>
          <p:cNvSpPr txBox="1"/>
          <p:nvPr/>
        </p:nvSpPr>
        <p:spPr>
          <a:xfrm>
            <a:off x="3057789" y="4018221"/>
            <a:ext cx="2872181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685800"/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earch 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nput</a:t>
            </a:r>
          </a:p>
          <a:p>
            <a:pPr algn="ctr" defTabSz="685800"/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search 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erm or topic)</a:t>
            </a:r>
          </a:p>
          <a:p>
            <a:pPr algn="ctr" defTabSz="685800"/>
            <a:r>
              <a:rPr lang="en-US" altLang="ja-JP" sz="1600" dirty="0" err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hikyuu-keigan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(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earch term</a:t>
            </a:r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7A5FF38-F05B-41B4-95F5-267644DA1A24}"/>
              </a:ext>
            </a:extLst>
          </p:cNvPr>
          <p:cNvSpPr txBox="1"/>
          <p:nvPr/>
        </p:nvSpPr>
        <p:spPr>
          <a:xfrm>
            <a:off x="79028" y="86375"/>
            <a:ext cx="544970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/>
            <a:r>
              <a:rPr lang="en-US" altLang="ja-JP" sz="15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5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1. Google Trends search strategy</a:t>
            </a:r>
            <a:endParaRPr lang="en-US" altLang="ja-JP" sz="1500" b="1" dirty="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9E0160A-B842-433C-943E-AC18D785832C}"/>
              </a:ext>
            </a:extLst>
          </p:cNvPr>
          <p:cNvSpPr txBox="1"/>
          <p:nvPr/>
        </p:nvSpPr>
        <p:spPr>
          <a:xfrm>
            <a:off x="3267987" y="5341406"/>
            <a:ext cx="2451780" cy="1077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685800"/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earch Category</a:t>
            </a:r>
          </a:p>
          <a:p>
            <a:pPr algn="ctr" defTabSz="685800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ll category</a:t>
            </a:r>
          </a:p>
          <a:p>
            <a:pPr algn="ctr" defTabSz="685800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nd</a:t>
            </a:r>
          </a:p>
          <a:p>
            <a:pPr algn="ctr" defTabSz="685800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ealth category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33F2D230-593F-4911-A71F-BB85ED98F1A6}"/>
              </a:ext>
            </a:extLst>
          </p:cNvPr>
          <p:cNvCxnSpPr>
            <a:cxnSpLocks/>
            <a:stCxn id="40" idx="2"/>
            <a:endCxn id="45" idx="0"/>
          </p:cNvCxnSpPr>
          <p:nvPr/>
        </p:nvCxnSpPr>
        <p:spPr>
          <a:xfrm flipH="1">
            <a:off x="4493877" y="4803051"/>
            <a:ext cx="2" cy="53835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3653599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4</Words>
  <Application>Microsoft Office PowerPoint</Application>
  <PresentationFormat>画面に合わせる (4:3)</PresentationFormat>
  <Paragraphs>1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1_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deharu Hagiya</dc:creator>
  <cp:lastModifiedBy>Hideharu Hagiya</cp:lastModifiedBy>
  <cp:revision>1</cp:revision>
  <dcterms:created xsi:type="dcterms:W3CDTF">2022-02-05T23:43:39Z</dcterms:created>
  <dcterms:modified xsi:type="dcterms:W3CDTF">2022-02-05T23:44:21Z</dcterms:modified>
</cp:coreProperties>
</file>